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70" r:id="rId2"/>
    <p:sldId id="369" r:id="rId3"/>
  </p:sldIdLst>
  <p:sldSz cx="7772400" cy="10058400"/>
  <p:notesSz cx="6858000" cy="9144000"/>
  <p:custDataLst>
    <p:tags r:id="rId4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2" autoAdjust="0"/>
    <p:restoredTop sz="94660"/>
  </p:normalViewPr>
  <p:slideViewPr>
    <p:cSldViewPr snapToGrid="0">
      <p:cViewPr varScale="1">
        <p:scale>
          <a:sx n="63" d="100"/>
          <a:sy n="63" d="100"/>
        </p:scale>
        <p:origin x="256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E6319-4D51-4355-A209-B71006B1EB93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DBE0B-E69B-4FBC-AA39-FF14760CF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8571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E6319-4D51-4355-A209-B71006B1EB93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DBE0B-E69B-4FBC-AA39-FF14760CF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33877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E6319-4D51-4355-A209-B71006B1EB93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DBE0B-E69B-4FBC-AA39-FF14760CF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324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E6319-4D51-4355-A209-B71006B1EB93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DBE0B-E69B-4FBC-AA39-FF14760CF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80083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E6319-4D51-4355-A209-B71006B1EB93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DBE0B-E69B-4FBC-AA39-FF14760CF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9882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E6319-4D51-4355-A209-B71006B1EB93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DBE0B-E69B-4FBC-AA39-FF14760CF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4738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E6319-4D51-4355-A209-B71006B1EB93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DBE0B-E69B-4FBC-AA39-FF14760CF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47810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E6319-4D51-4355-A209-B71006B1EB93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DBE0B-E69B-4FBC-AA39-FF14760CF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620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E6319-4D51-4355-A209-B71006B1EB93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DBE0B-E69B-4FBC-AA39-FF14760CF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6892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E6319-4D51-4355-A209-B71006B1EB93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DBE0B-E69B-4FBC-AA39-FF14760CF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2347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E6319-4D51-4355-A209-B71006B1EB93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4DBE0B-E69B-4FBC-AA39-FF14760CF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5344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0E6319-4D51-4355-A209-B71006B1EB93}" type="datetimeFigureOut">
              <a:rPr lang="en-US" smtClean="0"/>
              <a:t>4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4DBE0B-E69B-4FBC-AA39-FF14760CF7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0570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9248782F-D8FC-5AA5-4BE6-293C707F3529}"/>
              </a:ext>
            </a:extLst>
          </p:cNvPr>
          <p:cNvSpPr txBox="1"/>
          <p:nvPr/>
        </p:nvSpPr>
        <p:spPr>
          <a:xfrm>
            <a:off x="916686" y="5657334"/>
            <a:ext cx="5939028" cy="1384995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4 Fig.  Insertion site of the </a:t>
            </a:r>
            <a:r>
              <a:rPr kumimoji="0" lang="en-US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cipenserid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herpesvirus 3 (AciHV-3) LSGO genome within the </a:t>
            </a:r>
            <a:r>
              <a:rPr kumimoji="0" lang="en-US" sz="12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cipenser </a:t>
            </a:r>
            <a:r>
              <a:rPr kumimoji="0" lang="en-US" sz="1200" b="1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ulvescens</a:t>
            </a:r>
            <a:r>
              <a:rPr kumimoji="0" lang="en-US" sz="12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8S – 18S rRNA intergenic spacer region.  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LASTN analysis of the </a:t>
            </a:r>
            <a:r>
              <a:rPr kumimoji="0" lang="en-US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virus:host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junction in contigs ptg001137l and ptg009089l revealed that the AciHV-3 LSGO genome (blue text) was inserted between nucleotides 6,414 and 6,415 of sequence corresponding to the 28S-18S rRNA intergenic spacer region reported for </a:t>
            </a:r>
            <a:r>
              <a:rPr kumimoji="0" lang="en-US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enbank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accession number FJ688020.1 (black text).  Each contig contained the </a:t>
            </a:r>
            <a:r>
              <a:rPr kumimoji="0" lang="en-US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virus:host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junction at the 3’ end of the virus U region.  Since the virus sequence was 5’ truncated, the junction at the 5’ end of the U region (i.e. adjacent to FJ688020.1 </a:t>
            </a:r>
            <a:r>
              <a:rPr kumimoji="0" lang="en-US" sz="10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t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6,414) was not present in the contig.  It is only displayed here to provide context for the insertion site. </a:t>
            </a:r>
            <a:r>
              <a:rPr lang="en-US" sz="1000" kern="12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LSGO, Lake Sturgeon gonad. </a:t>
            </a: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+mn-cs"/>
              </a:rPr>
              <a:t> 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B7B1721-7C23-BA43-0D01-97AD99A4CC49}"/>
              </a:ext>
            </a:extLst>
          </p:cNvPr>
          <p:cNvSpPr txBox="1"/>
          <p:nvPr/>
        </p:nvSpPr>
        <p:spPr>
          <a:xfrm>
            <a:off x="916686" y="7205845"/>
            <a:ext cx="5939028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0" i="1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</a:rPr>
              <a:t>Any use of trade, firm, or product names is for descriptive purposes only and does not imply endorsement by the U.S. Government.</a:t>
            </a:r>
            <a:r>
              <a:rPr lang="en-US" sz="800" dirty="0"/>
              <a:t>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020BA1F-240A-DB62-7C9D-10FB910EB2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9112" y="2600236"/>
            <a:ext cx="6734175" cy="29813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32279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F2449EA1-A9D0-34DA-A859-BA05ACB2499C}"/>
              </a:ext>
            </a:extLst>
          </p:cNvPr>
          <p:cNvSpPr txBox="1"/>
          <p:nvPr/>
        </p:nvSpPr>
        <p:spPr>
          <a:xfrm>
            <a:off x="88900" y="4706034"/>
            <a:ext cx="7581899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en-US" sz="9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ourier New" panose="02070309020205020404" pitchFamily="49" charset="0"/>
                <a:ea typeface="+mn-ea"/>
                <a:cs typeface="Courier New" panose="02070309020205020404" pitchFamily="49" charset="0"/>
              </a:rPr>
              <a:t>ggcctcggcttgatggaacttgatataccctacttaggg</a:t>
            </a:r>
            <a:r>
              <a:rPr kumimoji="0" lang="en-US" altLang="en-US" sz="900" b="0" i="0" u="none" strike="noStrike" kern="1200" cap="none" spc="0" normalizeH="0" baseline="0" noProof="0" dirty="0">
                <a:ln>
                  <a:noFill/>
                </a:ln>
                <a:solidFill>
                  <a:srgbClr val="6D9D9D"/>
                </a:solidFill>
                <a:effectLst/>
                <a:uLnTx/>
                <a:uFillTx/>
                <a:latin typeface="Courier New" panose="02070309020205020404" pitchFamily="49" charset="0"/>
                <a:ea typeface="+mn-ea"/>
                <a:cs typeface="Courier New" panose="02070309020205020404" pitchFamily="49" charset="0"/>
              </a:rPr>
              <a:t>(………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srgbClr val="6D9D9D"/>
                </a:solidFill>
                <a:effectLst/>
                <a:uLnTx/>
                <a:uFillTx/>
                <a:latin typeface="Courier New" panose="02070309020205020404" pitchFamily="49" charset="0"/>
                <a:ea typeface="+mn-ea"/>
                <a:cs typeface="Courier New" panose="02070309020205020404" pitchFamily="49" charset="0"/>
              </a:rPr>
              <a:t>AAAAGGGCTGTCTGCCCTAAATAGGG)</a:t>
            </a:r>
            <a:r>
              <a:rPr kumimoji="0" lang="en-US" altLang="en-US" sz="900" b="0" i="0" u="none" strike="noStrike" kern="120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Courier New" panose="02070309020205020404" pitchFamily="49" charset="0"/>
                <a:ea typeface="+mn-ea"/>
                <a:cs typeface="Courier New" panose="02070309020205020404" pitchFamily="49" charset="0"/>
              </a:rPr>
              <a:t>ttaggtggtccccggacaccctttctcgtctcttctcg</a:t>
            </a:r>
            <a:endParaRPr kumimoji="0" 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ourier New" panose="02070309020205020404" pitchFamily="49" charset="0"/>
              <a:ea typeface="+mn-ea"/>
              <a:cs typeface="Courier New" panose="02070309020205020404" pitchFamily="49" charset="0"/>
            </a:endParaRP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BC9C5BB6-A684-1D22-31EE-C1E207200646}"/>
              </a:ext>
            </a:extLst>
          </p:cNvPr>
          <p:cNvCxnSpPr>
            <a:cxnSpLocks/>
          </p:cNvCxnSpPr>
          <p:nvPr/>
        </p:nvCxnSpPr>
        <p:spPr>
          <a:xfrm>
            <a:off x="2813050" y="4565650"/>
            <a:ext cx="0" cy="1905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86C5389D-C8E2-4652-993F-596DDB349DA5}"/>
              </a:ext>
            </a:extLst>
          </p:cNvPr>
          <p:cNvSpPr txBox="1"/>
          <p:nvPr/>
        </p:nvSpPr>
        <p:spPr>
          <a:xfrm>
            <a:off x="2424158" y="4203982"/>
            <a:ext cx="77777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J688020.1</a:t>
            </a:r>
          </a:p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6,414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8250714B-5911-DE60-DF3E-3BF6B09C9900}"/>
              </a:ext>
            </a:extLst>
          </p:cNvPr>
          <p:cNvCxnSpPr>
            <a:cxnSpLocks/>
          </p:cNvCxnSpPr>
          <p:nvPr/>
        </p:nvCxnSpPr>
        <p:spPr>
          <a:xfrm>
            <a:off x="4978402" y="4565650"/>
            <a:ext cx="0" cy="1905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4C4F491D-8C79-5072-FD50-48C206C94C0A}"/>
              </a:ext>
            </a:extLst>
          </p:cNvPr>
          <p:cNvSpPr txBox="1"/>
          <p:nvPr/>
        </p:nvSpPr>
        <p:spPr>
          <a:xfrm>
            <a:off x="4589514" y="4203982"/>
            <a:ext cx="77777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J688020.1</a:t>
            </a:r>
          </a:p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6,41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9D36D96-3B9C-7740-CDBA-3EC4FE239744}"/>
              </a:ext>
            </a:extLst>
          </p:cNvPr>
          <p:cNvSpPr txBox="1"/>
          <p:nvPr/>
        </p:nvSpPr>
        <p:spPr>
          <a:xfrm>
            <a:off x="3445829" y="4426866"/>
            <a:ext cx="9188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6D9D9D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ciHV-3 LSGO</a:t>
            </a:r>
          </a:p>
        </p:txBody>
      </p:sp>
      <p:sp>
        <p:nvSpPr>
          <p:cNvPr id="14" name="Right Brace 13">
            <a:extLst>
              <a:ext uri="{FF2B5EF4-FFF2-40B4-BE49-F238E27FC236}">
                <a16:creationId xmlns:a16="http://schemas.microsoft.com/office/drawing/2014/main" id="{CED7DAF1-4C53-BB5A-B3AC-80F6550BC214}"/>
              </a:ext>
            </a:extLst>
          </p:cNvPr>
          <p:cNvSpPr/>
          <p:nvPr/>
        </p:nvSpPr>
        <p:spPr>
          <a:xfrm rot="16200000">
            <a:off x="3850389" y="3670506"/>
            <a:ext cx="109724" cy="2057400"/>
          </a:xfrm>
          <a:prstGeom prst="rightBrace">
            <a:avLst/>
          </a:prstGeom>
          <a:ln>
            <a:solidFill>
              <a:srgbClr val="6D9D9D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FAAB165-A26E-2A71-D5E6-B4F6104695E4}"/>
              </a:ext>
            </a:extLst>
          </p:cNvPr>
          <p:cNvSpPr txBox="1"/>
          <p:nvPr/>
        </p:nvSpPr>
        <p:spPr>
          <a:xfrm>
            <a:off x="265792" y="5455920"/>
            <a:ext cx="7228114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4 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ig.  Insertion site of the </a:t>
            </a:r>
            <a:r>
              <a:rPr kumimoji="0" lang="en-US" sz="11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cipenserid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herpesvirus 3 (AciHV-3) LSGO genome within the </a:t>
            </a:r>
            <a:r>
              <a:rPr kumimoji="0" lang="en-US" sz="11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cipenser </a:t>
            </a:r>
            <a:r>
              <a:rPr kumimoji="0" lang="en-US" sz="1100" b="1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ulvescens</a:t>
            </a:r>
            <a:r>
              <a:rPr kumimoji="0" lang="en-US" sz="11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8S – 18S rRNA intergenic spacer region. 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LASTN analysis of the </a:t>
            </a:r>
            <a:r>
              <a:rPr kumimoji="0" lang="en-US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virus:host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junction in contigs ptg001137l and ptg009089l revealed that the AciHV-3 LSGO genome (blue text) was inserted between nucleotides 6,414 and 6,415 of sequence corresponding to the 28S-18S rRNA intergenic spacer region reported for </a:t>
            </a:r>
            <a:r>
              <a:rPr kumimoji="0" lang="en-US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Genbank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accession number FJ688020.1 (black text).  Each contig contained the </a:t>
            </a:r>
            <a:r>
              <a:rPr kumimoji="0" lang="en-US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virus:host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junction at the 3’ end of the virus U region.  Since the virus sequence was 5’ truncated, the junction at the 5’ end of the U region (i.e. adjacent to FJ688020.1 </a:t>
            </a:r>
            <a:r>
              <a:rPr kumimoji="0" lang="en-US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t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6,414) was not present in the contig.  It is only displayed here to provide context for the insertion site. </a:t>
            </a:r>
            <a:r>
              <a:rPr lang="en-US" sz="1100" kern="12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LSGO, Lake Sturgeon gonad. 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+mn-cs"/>
              </a:rPr>
              <a:t>  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71F2092E-51B6-634A-9246-C4C852BF75D8}"/>
              </a:ext>
            </a:extLst>
          </p:cNvPr>
          <p:cNvCxnSpPr>
            <a:cxnSpLocks/>
          </p:cNvCxnSpPr>
          <p:nvPr/>
        </p:nvCxnSpPr>
        <p:spPr>
          <a:xfrm flipV="1">
            <a:off x="4862197" y="4878070"/>
            <a:ext cx="0" cy="190500"/>
          </a:xfrm>
          <a:prstGeom prst="straightConnector1">
            <a:avLst/>
          </a:prstGeom>
          <a:ln>
            <a:solidFill>
              <a:srgbClr val="6D9D9D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5CCA24DB-6FF5-B309-9970-65E99667F86F}"/>
              </a:ext>
            </a:extLst>
          </p:cNvPr>
          <p:cNvSpPr txBox="1"/>
          <p:nvPr/>
        </p:nvSpPr>
        <p:spPr>
          <a:xfrm>
            <a:off x="4303390" y="5031361"/>
            <a:ext cx="1117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6D9D9D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’ end of U region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EA51A79-44CF-D695-4A27-E3F2E0D47924}"/>
              </a:ext>
            </a:extLst>
          </p:cNvPr>
          <p:cNvSpPr txBox="1"/>
          <p:nvPr/>
        </p:nvSpPr>
        <p:spPr>
          <a:xfrm>
            <a:off x="398183" y="4556200"/>
            <a:ext cx="21900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8S-18S rRNA intergenic spacer regio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EA7B483-9638-0E2C-ACBD-F6B95FE543F3}"/>
              </a:ext>
            </a:extLst>
          </p:cNvPr>
          <p:cNvSpPr txBox="1"/>
          <p:nvPr/>
        </p:nvSpPr>
        <p:spPr>
          <a:xfrm>
            <a:off x="5151064" y="4556200"/>
            <a:ext cx="21900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8S-18S rRNA intergenic spacer region</a:t>
            </a:r>
          </a:p>
        </p:txBody>
      </p:sp>
    </p:spTree>
    <p:extLst>
      <p:ext uri="{BB962C8B-B14F-4D97-AF65-F5344CB8AC3E}">
        <p14:creationId xmlns:p14="http://schemas.microsoft.com/office/powerpoint/2010/main" val="2559320784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ENGAGE" val="{&quot;SavedSwatch&quot;:&quot;-14272694|-12223080|-16154294|-9539986|-16777216|Fisheries and Oceans Canada&quot;,&quot;Id&quot;:&quot;6702b2094542452b087ea0e6&quot;,&quot;SmartGridHorizontal&quot;:0,&quot;LinkedExcelSources&quot;:{},&quot;LinkedProjectSources&quot;:{},&quot;FlowConfig&quot;:{&quot;Canvas&quot;:{&quot;Slide&quot;:-1,&quot;Width&quot;:0,&quot;Height&quot;:0},&quot;Timeline&quot;:{&quot;Actions&quot;:[]}},&quot;LinkedSlideMergeSources&quot;:{},&quot;LinkedSharePointSlideMergeSources&quot;:{}}"/>
</p:tagLst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722</TotalTime>
  <Words>361</Words>
  <Application>Microsoft Office PowerPoint</Application>
  <PresentationFormat>Custom</PresentationFormat>
  <Paragraphs>1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Arial</vt:lpstr>
      <vt:lpstr>Calibri</vt:lpstr>
      <vt:lpstr>Calibri Light</vt:lpstr>
      <vt:lpstr>Courier New</vt:lpstr>
      <vt:lpstr>Palatino Linotype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outhier, Sharon (DFO/MPO)</dc:creator>
  <cp:lastModifiedBy>Clouthier, Sharon (DFO/MPO)</cp:lastModifiedBy>
  <cp:revision>17</cp:revision>
  <dcterms:created xsi:type="dcterms:W3CDTF">2024-09-27T15:00:22Z</dcterms:created>
  <dcterms:modified xsi:type="dcterms:W3CDTF">2025-04-04T01:17:17Z</dcterms:modified>
</cp:coreProperties>
</file>